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1" r:id="rId6"/>
    <p:sldId id="260" r:id="rId7"/>
    <p:sldId id="262" r:id="rId8"/>
    <p:sldId id="275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4" r:id="rId20"/>
    <p:sldId id="273" r:id="rId21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771DBD-C91A-4D49-A354-55A143E2C6B7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DF00E8-5802-40A5-A7F1-15A69E5AF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898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939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954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3590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6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03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809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912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678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83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336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796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C32A7-0180-4D04-B60E-00A055657245}" type="datetimeFigureOut">
              <a:rPr lang="en-US" smtClean="0"/>
              <a:t>2/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0ACD3-6CE1-47BD-83FF-080227AD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030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g"/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g"/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g"/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jpg"/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g"/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g"/><Relationship Id="rId2" Type="http://schemas.openxmlformats.org/officeDocument/2006/relationships/image" Target="../media/image38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075" y="257596"/>
            <a:ext cx="5715000" cy="42767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075" y="4630778"/>
            <a:ext cx="5715000" cy="425767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68101" y="2210764"/>
            <a:ext cx="2858947" cy="123849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868101" y="6032338"/>
            <a:ext cx="2858947" cy="45515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583075" y="257596"/>
            <a:ext cx="2144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1.A (upper </a:t>
            </a:r>
            <a:r>
              <a:rPr lang="en-US" dirty="0"/>
              <a:t>panel</a:t>
            </a:r>
            <a:r>
              <a:rPr lang="en-US" dirty="0" smtClean="0"/>
              <a:t>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83075" y="4630778"/>
            <a:ext cx="2116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1.A (lower panel)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3704137" y="259931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3704137" y="612141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7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5595695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373" y="257595"/>
            <a:ext cx="5715000" cy="42767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373" y="4693654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918750" y="1893267"/>
            <a:ext cx="2880167" cy="100538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082724" y="6467195"/>
            <a:ext cx="2880167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29373" y="257595"/>
            <a:ext cx="14702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D – ME7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629373" y="4693654"/>
            <a:ext cx="14847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E – 263K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764669" y="211895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5919485" y="6693516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8082068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766" y="313216"/>
            <a:ext cx="5715000" cy="4276725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766" y="4702275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978552" y="1524805"/>
            <a:ext cx="2880167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649392" y="6457549"/>
            <a:ext cx="2880167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555766" y="313216"/>
            <a:ext cx="15087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E – 139H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555766" y="4738861"/>
            <a:ext cx="12698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E – HY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858719" y="171640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529559" y="670213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805163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26" y="383783"/>
            <a:ext cx="5715000" cy="4276725"/>
          </a:xfr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26" y="4760149"/>
            <a:ext cx="5715000" cy="427672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077655" y="2255939"/>
            <a:ext cx="2880167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1813367" y="6532664"/>
            <a:ext cx="2006280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559926" y="383783"/>
            <a:ext cx="12698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E – DY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559926" y="4831217"/>
            <a:ext cx="13372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F – ELK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819647" y="676001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977350" y="244112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4661216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075" y="291186"/>
            <a:ext cx="5715000" cy="4276725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075" y="4667551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218481" y="1752320"/>
            <a:ext cx="2006280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935620" y="6805913"/>
            <a:ext cx="2965048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583075" y="291186"/>
            <a:ext cx="1499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F – DEER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583075" y="4681713"/>
            <a:ext cx="1586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G – REC 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224761" y="191021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865943" y="70030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216721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374" y="349059"/>
            <a:ext cx="5715000" cy="4276725"/>
          </a:xfr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374" y="4760149"/>
            <a:ext cx="5715000" cy="4276725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016642" y="2106591"/>
            <a:ext cx="2965048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1016642" y="6599498"/>
            <a:ext cx="2965048" cy="117209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629374" y="390161"/>
            <a:ext cx="1586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G – REC B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629374" y="4851552"/>
            <a:ext cx="1586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G – REC C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981690" y="234892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3981690" y="676001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5716702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649" y="269171"/>
            <a:ext cx="5715000" cy="42767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649" y="4690701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005067" y="2569579"/>
            <a:ext cx="2965048" cy="1203768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319514" y="6379579"/>
            <a:ext cx="2129742" cy="1203768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29374" y="390161"/>
            <a:ext cx="7991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5.C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629374" y="4747504"/>
            <a:ext cx="21706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5.D (Upper Panel)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891251" y="6328618"/>
            <a:ext cx="428264" cy="125472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677595" y="8401590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677595" y="8425797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970115" y="271931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3474820" y="658525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861314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626" y="338619"/>
            <a:ext cx="5715000" cy="42767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626" y="4736999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241384" y="2037144"/>
            <a:ext cx="2129742" cy="37039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513626" y="361769"/>
            <a:ext cx="21612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5.D (Lower Panel)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513625" y="4899033"/>
            <a:ext cx="7857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5.F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868100" y="1953389"/>
            <a:ext cx="373283" cy="490184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599464" y="4026360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/>
          <p:cNvSpPr txBox="1"/>
          <p:nvPr/>
        </p:nvSpPr>
        <p:spPr>
          <a:xfrm>
            <a:off x="599464" y="4050567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868099" y="6875360"/>
            <a:ext cx="4051141" cy="839797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3371126" y="208383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7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919240" y="691408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20822919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20" y="4576965"/>
            <a:ext cx="5215842" cy="3903188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937" y="266628"/>
            <a:ext cx="5206125" cy="4112363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195085" y="2801072"/>
            <a:ext cx="4684854" cy="89125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195085" y="6701742"/>
            <a:ext cx="2994950" cy="49771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840404" y="266628"/>
            <a:ext cx="8143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6.A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787890" y="4596089"/>
            <a:ext cx="81439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6.B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83178" y="256364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389779" y="652855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5165437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361" y="337485"/>
            <a:ext cx="5715000" cy="4276725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361" y="4774677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13119" y="1978136"/>
            <a:ext cx="4557533" cy="103128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3298785" y="6254861"/>
            <a:ext cx="1632030" cy="103128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529361" y="373344"/>
            <a:ext cx="8226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6.D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529361" y="4821293"/>
            <a:ext cx="8226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6.E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813119" y="6254862"/>
            <a:ext cx="2485666" cy="1031282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187616" y="8491903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187616" y="8516110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346473" y="211223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907665" y="653026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9046511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384" y="4562243"/>
            <a:ext cx="5715000" cy="4276725"/>
          </a:xfrm>
        </p:spPr>
      </p:pic>
      <p:sp>
        <p:nvSpPr>
          <p:cNvPr id="5" name="Rectangle 4"/>
          <p:cNvSpPr/>
          <p:nvPr/>
        </p:nvSpPr>
        <p:spPr>
          <a:xfrm>
            <a:off x="894141" y="7060557"/>
            <a:ext cx="2925505" cy="1226916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610384" y="4647673"/>
            <a:ext cx="22506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S2.A (upper panel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795466" y="72349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384" y="198311"/>
            <a:ext cx="5715000" cy="4276725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610384" y="198311"/>
            <a:ext cx="9108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S1.B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2551250" y="1598306"/>
            <a:ext cx="1696659" cy="920385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4202996" y="191999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533742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26" y="268037"/>
            <a:ext cx="5715000" cy="4276725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26" y="4670505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752354" y="1990845"/>
            <a:ext cx="2858947" cy="1157469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927904" y="6611074"/>
            <a:ext cx="3887164" cy="106294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559926" y="268037"/>
            <a:ext cx="7991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1.C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59926" y="4719551"/>
            <a:ext cx="21531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 1.D (upper panel)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3657601" y="1990845"/>
            <a:ext cx="1423687" cy="115746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206921" y="385524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206921" y="409731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081288" y="212940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815068" y="6762966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698104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500" y="4589483"/>
            <a:ext cx="5715000" cy="4276725"/>
          </a:xfr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500" y="199723"/>
            <a:ext cx="5715000" cy="427672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870993" y="7454096"/>
            <a:ext cx="2682436" cy="1053296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965520" y="2201119"/>
            <a:ext cx="2682436" cy="1053296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571500" y="214815"/>
            <a:ext cx="23388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S2.A (middle panel)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571499" y="4686721"/>
            <a:ext cx="22220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S2.A (lower panel)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3668693" y="2201120"/>
            <a:ext cx="914882" cy="1053296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210285" y="3942657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4210285" y="3966864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49646" y="231493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3544985" y="761806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854720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777" y="325909"/>
            <a:ext cx="5715000" cy="4276725"/>
          </a:xfr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777" y="4690700"/>
            <a:ext cx="5715000" cy="4276725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846881" y="2120096"/>
            <a:ext cx="3887164" cy="106294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846881" y="6297590"/>
            <a:ext cx="3887164" cy="1225953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536777" y="331168"/>
            <a:ext cx="21245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1.D </a:t>
            </a:r>
            <a:r>
              <a:rPr lang="en-US" dirty="0" smtClean="0"/>
              <a:t>(lower </a:t>
            </a:r>
            <a:r>
              <a:rPr lang="en-US" dirty="0"/>
              <a:t>panel)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08179" y="4690700"/>
            <a:ext cx="21448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2.A </a:t>
            </a:r>
            <a:r>
              <a:rPr lang="en-US" dirty="0"/>
              <a:t>(upper panel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734045" y="218727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4734045" y="663356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107932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860" y="292297"/>
            <a:ext cx="5715000" cy="4256892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860" y="4644402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951053" y="1784431"/>
            <a:ext cx="3667246" cy="47263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1675737" y="6546448"/>
            <a:ext cx="2942562" cy="113914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651860" y="364228"/>
            <a:ext cx="22330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2.A (middle </a:t>
            </a:r>
            <a:r>
              <a:rPr lang="en-US" dirty="0"/>
              <a:t>panel)</a:t>
            </a:r>
          </a:p>
        </p:txBody>
      </p:sp>
      <p:sp>
        <p:nvSpPr>
          <p:cNvPr id="9" name="Rectangle 8"/>
          <p:cNvSpPr/>
          <p:nvPr/>
        </p:nvSpPr>
        <p:spPr>
          <a:xfrm>
            <a:off x="651860" y="4705292"/>
            <a:ext cx="21162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2.A (lower </a:t>
            </a:r>
            <a:r>
              <a:rPr lang="en-US" dirty="0"/>
              <a:t>panel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618299" y="664426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594333" y="178443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7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182283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450" y="387931"/>
            <a:ext cx="5753100" cy="4256120"/>
          </a:xfrm>
        </p:spPr>
      </p:pic>
      <p:pic>
        <p:nvPicPr>
          <p:cNvPr id="5" name="Content Placeholder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450" y="4742956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974203" y="2279675"/>
            <a:ext cx="2313007" cy="75289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419109" y="6159349"/>
            <a:ext cx="2270567" cy="100538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552450" y="584147"/>
            <a:ext cx="7991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2.C</a:t>
            </a:r>
            <a:endParaRPr lang="en-US" dirty="0"/>
          </a:p>
        </p:txBody>
      </p:sp>
      <p:sp>
        <p:nvSpPr>
          <p:cNvPr id="9" name="Rectangle 8"/>
          <p:cNvSpPr/>
          <p:nvPr/>
        </p:nvSpPr>
        <p:spPr>
          <a:xfrm>
            <a:off x="574638" y="4780923"/>
            <a:ext cx="7991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2.E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3287211" y="2279241"/>
            <a:ext cx="914400" cy="753326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201611" y="3910858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4201611" y="3935065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201611" y="237749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657369" y="630827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287046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477" y="341574"/>
            <a:ext cx="5715000" cy="4276725"/>
          </a:xfrm>
          <a:prstGeom prst="rect">
            <a:avLst/>
          </a:prstGeom>
        </p:spPr>
      </p:pic>
      <p:pic>
        <p:nvPicPr>
          <p:cNvPr id="7" name="Content Placeholder 5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477" y="4735863"/>
            <a:ext cx="5715000" cy="4276725"/>
          </a:xfrm>
        </p:spPr>
      </p:pic>
      <p:sp>
        <p:nvSpPr>
          <p:cNvPr id="8" name="Rectangle 7"/>
          <p:cNvSpPr/>
          <p:nvPr/>
        </p:nvSpPr>
        <p:spPr>
          <a:xfrm>
            <a:off x="2048720" y="1977246"/>
            <a:ext cx="2270567" cy="100538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696411" y="6371535"/>
            <a:ext cx="3622876" cy="90894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490477" y="341574"/>
            <a:ext cx="8215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2.G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512919" y="4735863"/>
            <a:ext cx="7991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3.C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4319288" y="6354501"/>
            <a:ext cx="1213412" cy="925976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150976" y="4894046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4150976" y="4918253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310120" y="220293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5492179" y="644789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4173187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ontent Placeholder 7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179" y="302760"/>
            <a:ext cx="5715000" cy="4276725"/>
          </a:xfr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179" y="4679126"/>
            <a:ext cx="5715000" cy="4276725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706056" y="1915285"/>
            <a:ext cx="3912243" cy="100538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706056" y="6314798"/>
            <a:ext cx="3912243" cy="1208746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44179" y="302760"/>
            <a:ext cx="7991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3.F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460572" y="4697825"/>
            <a:ext cx="214488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A (upper panel)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4618299" y="1915286"/>
            <a:ext cx="1423687" cy="1005380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4147116" y="463219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4147116" y="487426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005086" y="204951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>
            <a:off x="4572239" y="678067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348979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626" y="511104"/>
            <a:ext cx="5715000" cy="4276725"/>
          </a:xfrm>
        </p:spPr>
      </p:pic>
      <p:sp>
        <p:nvSpPr>
          <p:cNvPr id="5" name="Rectangle 4"/>
          <p:cNvSpPr/>
          <p:nvPr/>
        </p:nvSpPr>
        <p:spPr>
          <a:xfrm>
            <a:off x="821803" y="1770927"/>
            <a:ext cx="4525701" cy="451412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513626" y="511104"/>
            <a:ext cx="21162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A (lower panel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347504" y="185813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37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231411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26" y="302760"/>
            <a:ext cx="5715000" cy="4276725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9926" y="4725425"/>
            <a:ext cx="5715000" cy="4276725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868102" y="1938432"/>
            <a:ext cx="4930814" cy="100538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/>
          <p:cNvSpPr/>
          <p:nvPr/>
        </p:nvSpPr>
        <p:spPr>
          <a:xfrm>
            <a:off x="2803003" y="6361097"/>
            <a:ext cx="2880167" cy="100538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559926" y="302759"/>
            <a:ext cx="7991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C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599468" y="4744803"/>
            <a:ext cx="14189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Fig </a:t>
            </a:r>
            <a:r>
              <a:rPr lang="en-US" dirty="0" smtClean="0"/>
              <a:t>4.D - RML</a:t>
            </a:r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379316" y="6330746"/>
            <a:ext cx="1423687" cy="1035731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208849" y="4807013"/>
            <a:ext cx="1933927" cy="393539"/>
          </a:xfrm>
          <a:prstGeom prst="rect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4208849" y="4831220"/>
            <a:ext cx="1933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related to study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5834839" y="208135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5663381" y="657161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5 </a:t>
            </a:r>
            <a:r>
              <a:rPr lang="en-US" sz="1200" dirty="0" err="1" smtClean="0"/>
              <a:t>kDa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01679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</TotalTime>
  <Words>264</Words>
  <Application>Microsoft Office PowerPoint</Application>
  <PresentationFormat>On-screen Show (4:3)</PresentationFormat>
  <Paragraphs>87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os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tdula, Jean Royce</dc:creator>
  <cp:lastModifiedBy>Gatdula, Jean Royce</cp:lastModifiedBy>
  <cp:revision>15</cp:revision>
  <dcterms:created xsi:type="dcterms:W3CDTF">2026-02-05T19:16:24Z</dcterms:created>
  <dcterms:modified xsi:type="dcterms:W3CDTF">2026-02-08T21:37:50Z</dcterms:modified>
</cp:coreProperties>
</file>